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2" r:id="rId2"/>
  </p:sldMasterIdLst>
  <p:notesMasterIdLst>
    <p:notesMasterId r:id="rId6"/>
  </p:notesMasterIdLst>
  <p:sldIdLst>
    <p:sldId id="263" r:id="rId3"/>
    <p:sldId id="262" r:id="rId4"/>
    <p:sldId id="264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360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3E1A05-A13C-4A22-B86C-2E18B9C2217C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17ACF0-C214-48F8-B5BC-7481B9B0AF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60035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ylogenetic tree of coat protein sequence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513ED24-2AA5-4CB1-953C-F6F68877ABA5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48068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2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sistency analysis of coat protein sequence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513ED24-2AA5-4CB1-953C-F6F68877ABA5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834684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4C279F-9313-4CDF-B1C9-7A6EC365DF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5C18586-9211-48BD-A344-B8CFC9E5DC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403" indent="0" algn="ctr">
              <a:buNone/>
              <a:defRPr sz="2889"/>
            </a:lvl2pPr>
            <a:lvl3pPr marL="1320810" indent="0" algn="ctr">
              <a:buNone/>
              <a:defRPr sz="2601"/>
            </a:lvl3pPr>
            <a:lvl4pPr marL="1981213" indent="0" algn="ctr">
              <a:buNone/>
              <a:defRPr sz="2311"/>
            </a:lvl4pPr>
            <a:lvl5pPr marL="2641618" indent="0" algn="ctr">
              <a:buNone/>
              <a:defRPr sz="2311"/>
            </a:lvl5pPr>
            <a:lvl6pPr marL="3302021" indent="0" algn="ctr">
              <a:buNone/>
              <a:defRPr sz="2311"/>
            </a:lvl6pPr>
            <a:lvl7pPr marL="3962428" indent="0" algn="ctr">
              <a:buNone/>
              <a:defRPr sz="2311"/>
            </a:lvl7pPr>
            <a:lvl8pPr marL="4622831" indent="0" algn="ctr">
              <a:buNone/>
              <a:defRPr sz="2311"/>
            </a:lvl8pPr>
            <a:lvl9pPr marL="5283234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AD4BFE-16D7-45D7-A27F-E721C1EE4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4A56A1-503E-4238-9725-4809DE484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783B39-BD97-43C4-8F90-0F4F94A57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8569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A2BB9A-CCCE-4038-BB2B-D3241AC6CE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BEB4DFD-F2E9-4F60-9F60-8BE28FA431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9B5A47-7A7D-4FE9-AAC1-7F30BB9A1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0BAA8A-0EA7-4D6D-840D-FF056964E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DEF3EC-50F8-4A00-A44A-EAEA6B198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6383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08B5095-5E60-4E88-A13B-3866D432D1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B33C8E7-C3EC-4B28-A97E-5A6EC833A3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C45A0A-D886-424F-8161-E55B12C61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9435E4-6CDF-4BC9-8803-3E0485A31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CDF4E8-058E-416E-A9BB-326C6EED5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12464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96942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644141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01457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84728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14068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311925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47469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652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A970C2-51FE-4D3C-B6A7-5EDAE1289C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9F1529-597E-4CFA-9BE3-ACDA83A92D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EDB693-B759-4607-ADC4-D9D89170C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473074-3E2A-427C-BA3E-D613F9BBF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067DFF-3D10-42E6-AFCD-8B34B810A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414301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332051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802217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E21C6-9AC9-4B9B-BF5D-4614161FB277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95E64-25DD-46EF-A415-1442B370BE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2167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1B35E3-48EC-4B72-A901-C5F428C62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446AA4-3DE3-4A32-AB29-36548BB614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7" y="6629229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403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810" indent="0">
              <a:buNone/>
              <a:defRPr sz="2601">
                <a:solidFill>
                  <a:schemeClr val="tx1">
                    <a:tint val="75000"/>
                  </a:schemeClr>
                </a:solidFill>
              </a:defRPr>
            </a:lvl3pPr>
            <a:lvl4pPr marL="1981213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61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2021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42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831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234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7C631B-2D54-42E9-A8BD-DB2707A6D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258E9A-E2E6-4C71-BDD2-5DCB82ACE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0E5AC6-4F5F-4CDC-9E92-ACE8B3DD05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673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576D8A-5EFC-40DB-A5C9-9F51BE02D7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D432DC9-C3D5-4DAE-8D7A-F035B88AB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0B0389B-9C99-4B0C-9B80-A0B544864D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6BB810-733E-4BA4-874E-9D0399053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8FBFB2-0D2A-4BF3-991D-0DE479BCB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9386BE-532D-480B-8875-4BA42F496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2481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64EC1A-22EA-4335-BFAB-C8F4C7C55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4EB3192-BC9B-4A97-A06A-C76960D5D0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403" indent="0">
              <a:buNone/>
              <a:defRPr sz="2889" b="1"/>
            </a:lvl2pPr>
            <a:lvl3pPr marL="1320810" indent="0">
              <a:buNone/>
              <a:defRPr sz="2601" b="1"/>
            </a:lvl3pPr>
            <a:lvl4pPr marL="1981213" indent="0">
              <a:buNone/>
              <a:defRPr sz="2311" b="1"/>
            </a:lvl4pPr>
            <a:lvl5pPr marL="2641618" indent="0">
              <a:buNone/>
              <a:defRPr sz="2311" b="1"/>
            </a:lvl5pPr>
            <a:lvl6pPr marL="3302021" indent="0">
              <a:buNone/>
              <a:defRPr sz="2311" b="1"/>
            </a:lvl6pPr>
            <a:lvl7pPr marL="3962428" indent="0">
              <a:buNone/>
              <a:defRPr sz="2311" b="1"/>
            </a:lvl7pPr>
            <a:lvl8pPr marL="4622831" indent="0">
              <a:buNone/>
              <a:defRPr sz="2311" b="1"/>
            </a:lvl8pPr>
            <a:lvl9pPr marL="5283234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A5CBBDF-2026-4BE9-826E-68DB9EDEF5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C8EAB46-8061-4501-B6C3-DA10D7E82B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403" indent="0">
              <a:buNone/>
              <a:defRPr sz="2889" b="1"/>
            </a:lvl2pPr>
            <a:lvl3pPr marL="1320810" indent="0">
              <a:buNone/>
              <a:defRPr sz="2601" b="1"/>
            </a:lvl3pPr>
            <a:lvl4pPr marL="1981213" indent="0">
              <a:buNone/>
              <a:defRPr sz="2311" b="1"/>
            </a:lvl4pPr>
            <a:lvl5pPr marL="2641618" indent="0">
              <a:buNone/>
              <a:defRPr sz="2311" b="1"/>
            </a:lvl5pPr>
            <a:lvl6pPr marL="3302021" indent="0">
              <a:buNone/>
              <a:defRPr sz="2311" b="1"/>
            </a:lvl6pPr>
            <a:lvl7pPr marL="3962428" indent="0">
              <a:buNone/>
              <a:defRPr sz="2311" b="1"/>
            </a:lvl7pPr>
            <a:lvl8pPr marL="4622831" indent="0">
              <a:buNone/>
              <a:defRPr sz="2311" b="1"/>
            </a:lvl8pPr>
            <a:lvl9pPr marL="5283234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189CAC8-585B-4642-80FF-1D93FF7F30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7D35362-27CC-48CF-B484-C9B732548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44E5FF9-F6B4-49E0-A970-C013AACF8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1408749-B49A-49C2-9DB2-42C615680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0773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57792D-DD21-4467-916A-2164628EF3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EBC09E8-4873-4566-8E4F-86F95AE42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8BAA40E-541E-4C6E-A3D4-66D22B47C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5287A89-D9A1-4171-AAA2-9E2D764E1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3838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F772FFF-6A30-42BD-8078-D616A6258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DEBAC6A-4A45-423F-997B-6DCA2E7747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187DC75-8493-4C43-B7DF-5B88556DB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013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8F57B9-A00D-4FB3-A9FA-A5F566863A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F1719C-2C3B-416F-B19F-F7FB469BD5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D5ADA9B-3FD6-47F1-AC05-65B2733EB1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403" indent="0">
              <a:buNone/>
              <a:defRPr sz="2024"/>
            </a:lvl2pPr>
            <a:lvl3pPr marL="1320810" indent="0">
              <a:buNone/>
              <a:defRPr sz="1733"/>
            </a:lvl3pPr>
            <a:lvl4pPr marL="1981213" indent="0">
              <a:buNone/>
              <a:defRPr sz="1446"/>
            </a:lvl4pPr>
            <a:lvl5pPr marL="2641618" indent="0">
              <a:buNone/>
              <a:defRPr sz="1446"/>
            </a:lvl5pPr>
            <a:lvl6pPr marL="3302021" indent="0">
              <a:buNone/>
              <a:defRPr sz="1446"/>
            </a:lvl6pPr>
            <a:lvl7pPr marL="3962428" indent="0">
              <a:buNone/>
              <a:defRPr sz="1446"/>
            </a:lvl7pPr>
            <a:lvl8pPr marL="4622831" indent="0">
              <a:buNone/>
              <a:defRPr sz="1446"/>
            </a:lvl8pPr>
            <a:lvl9pPr marL="5283234" indent="0">
              <a:buNone/>
              <a:defRPr sz="144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324680-4849-47D6-A6C7-85634EA87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4EF230A-669E-4830-84A6-8686CB922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09153A-581F-469E-87B8-CA7DDA9EC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86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1B994-2B09-4B67-AE5E-73AB5562B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ADAB0C4-8765-437C-AE56-FB47BC02F8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403" indent="0">
              <a:buNone/>
              <a:defRPr sz="4044"/>
            </a:lvl2pPr>
            <a:lvl3pPr marL="1320810" indent="0">
              <a:buNone/>
              <a:defRPr sz="3467"/>
            </a:lvl3pPr>
            <a:lvl4pPr marL="1981213" indent="0">
              <a:buNone/>
              <a:defRPr sz="2889"/>
            </a:lvl4pPr>
            <a:lvl5pPr marL="2641618" indent="0">
              <a:buNone/>
              <a:defRPr sz="2889"/>
            </a:lvl5pPr>
            <a:lvl6pPr marL="3302021" indent="0">
              <a:buNone/>
              <a:defRPr sz="2889"/>
            </a:lvl6pPr>
            <a:lvl7pPr marL="3962428" indent="0">
              <a:buNone/>
              <a:defRPr sz="2889"/>
            </a:lvl7pPr>
            <a:lvl8pPr marL="4622831" indent="0">
              <a:buNone/>
              <a:defRPr sz="2889"/>
            </a:lvl8pPr>
            <a:lvl9pPr marL="5283234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2E34BCD-FC39-4C14-A586-71D336BF05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403" indent="0">
              <a:buNone/>
              <a:defRPr sz="2024"/>
            </a:lvl2pPr>
            <a:lvl3pPr marL="1320810" indent="0">
              <a:buNone/>
              <a:defRPr sz="1733"/>
            </a:lvl3pPr>
            <a:lvl4pPr marL="1981213" indent="0">
              <a:buNone/>
              <a:defRPr sz="1446"/>
            </a:lvl4pPr>
            <a:lvl5pPr marL="2641618" indent="0">
              <a:buNone/>
              <a:defRPr sz="1446"/>
            </a:lvl5pPr>
            <a:lvl6pPr marL="3302021" indent="0">
              <a:buNone/>
              <a:defRPr sz="1446"/>
            </a:lvl6pPr>
            <a:lvl7pPr marL="3962428" indent="0">
              <a:buNone/>
              <a:defRPr sz="1446"/>
            </a:lvl7pPr>
            <a:lvl8pPr marL="4622831" indent="0">
              <a:buNone/>
              <a:defRPr sz="1446"/>
            </a:lvl8pPr>
            <a:lvl9pPr marL="5283234" indent="0">
              <a:buNone/>
              <a:defRPr sz="144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8491F5-F844-4241-A8C5-A2B470739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03E2D87-74C4-4861-ADEB-115517650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700A164-D44E-47EF-9EFB-934E01DA4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351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4C9EDAC-C3A9-4B23-96E9-9061DB215B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6204F4A-C742-4DA1-943D-F32AF3E15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9E5632-EB90-4AFF-AB7E-00D3460BDD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DAA3AB-01F5-46C5-8E36-039DBBBAB5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10686A-9D5C-4ACC-82EA-28F5AF251C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3466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810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203" indent="-330203" algn="l" defTabSz="1320810" rtl="0" eaLnBrk="1" latinLnBrk="0" hangingPunct="1">
        <a:lnSpc>
          <a:spcPct val="90000"/>
        </a:lnSpc>
        <a:spcBef>
          <a:spcPts val="1446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609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1013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418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1" kern="1200">
          <a:solidFill>
            <a:schemeClr val="tx1"/>
          </a:solidFill>
          <a:latin typeface="+mn-lt"/>
          <a:ea typeface="+mn-ea"/>
          <a:cs typeface="+mn-cs"/>
        </a:defRPr>
      </a:lvl4pPr>
      <a:lvl5pPr marL="2971821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1" kern="1200">
          <a:solidFill>
            <a:schemeClr val="tx1"/>
          </a:solidFill>
          <a:latin typeface="+mn-lt"/>
          <a:ea typeface="+mn-ea"/>
          <a:cs typeface="+mn-cs"/>
        </a:defRPr>
      </a:lvl5pPr>
      <a:lvl6pPr marL="3632225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1" kern="1200">
          <a:solidFill>
            <a:schemeClr val="tx1"/>
          </a:solidFill>
          <a:latin typeface="+mn-lt"/>
          <a:ea typeface="+mn-ea"/>
          <a:cs typeface="+mn-cs"/>
        </a:defRPr>
      </a:lvl6pPr>
      <a:lvl7pPr marL="4292631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1" kern="1200">
          <a:solidFill>
            <a:schemeClr val="tx1"/>
          </a:solidFill>
          <a:latin typeface="+mn-lt"/>
          <a:ea typeface="+mn-ea"/>
          <a:cs typeface="+mn-cs"/>
        </a:defRPr>
      </a:lvl7pPr>
      <a:lvl8pPr marL="4953034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1" kern="1200">
          <a:solidFill>
            <a:schemeClr val="tx1"/>
          </a:solidFill>
          <a:latin typeface="+mn-lt"/>
          <a:ea typeface="+mn-ea"/>
          <a:cs typeface="+mn-cs"/>
        </a:defRPr>
      </a:lvl8pPr>
      <a:lvl9pPr marL="5613440" indent="-330203" algn="l" defTabSz="1320810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1pPr>
      <a:lvl2pPr marL="660403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2pPr>
      <a:lvl3pPr marL="1320810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3pPr>
      <a:lvl4pPr marL="1981213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4pPr>
      <a:lvl5pPr marL="2641618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5pPr>
      <a:lvl6pPr marL="3302021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6pPr>
      <a:lvl7pPr marL="3962428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7pPr>
      <a:lvl8pPr marL="4622831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8pPr>
      <a:lvl9pPr marL="5283234" algn="l" defTabSz="1320810" rtl="0" eaLnBrk="1" latinLnBrk="0" hangingPunct="1">
        <a:defRPr sz="26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6B932-7D00-4859-B91C-1576B942D0AD}" type="datetimeFigureOut">
              <a:rPr lang="zh-CN" altLang="en-US" smtClean="0"/>
              <a:t>2024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CC312F-C9A9-406F-AC7B-4131647002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884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3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76FB5394-8835-467F-A848-B531510B5FA5}"/>
              </a:ext>
            </a:extLst>
          </p:cNvPr>
          <p:cNvGrpSpPr/>
          <p:nvPr/>
        </p:nvGrpSpPr>
        <p:grpSpPr>
          <a:xfrm>
            <a:off x="1562100" y="127000"/>
            <a:ext cx="3644899" cy="9639300"/>
            <a:chOff x="1765299" y="329395"/>
            <a:chExt cx="3368675" cy="9458770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3A49F84-F3B9-407E-A5C5-3AA3A4DFF2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75" r="-1" b="-174"/>
            <a:stretch/>
          </p:blipFill>
          <p:spPr>
            <a:xfrm>
              <a:off x="1765299" y="329395"/>
              <a:ext cx="3368675" cy="9458770"/>
            </a:xfrm>
            <a:prstGeom prst="rect">
              <a:avLst/>
            </a:prstGeom>
          </p:spPr>
        </p:pic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E5D4DDA9-8308-4187-86F7-C6346F6C848C}"/>
                </a:ext>
              </a:extLst>
            </p:cNvPr>
            <p:cNvSpPr/>
            <p:nvPr/>
          </p:nvSpPr>
          <p:spPr>
            <a:xfrm>
              <a:off x="2565300" y="9109290"/>
              <a:ext cx="1251050" cy="2720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2"/>
              <a:endParaRPr lang="zh-CN" altLang="en-US">
                <a:solidFill>
                  <a:prstClr val="white"/>
                </a:solidFill>
                <a:latin typeface="等线" panose="020F0502020204030204"/>
                <a:ea typeface="等线" panose="02010600030101010101" pitchFamily="2" charset="-122"/>
              </a:endParaRPr>
            </a:p>
          </p:txBody>
        </p: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5A740278-96C6-4EB9-91A1-073BDAA5E577}"/>
              </a:ext>
            </a:extLst>
          </p:cNvPr>
          <p:cNvSpPr txBox="1"/>
          <p:nvPr/>
        </p:nvSpPr>
        <p:spPr>
          <a:xfrm>
            <a:off x="-1" y="0"/>
            <a:ext cx="342900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upplementary Figure S1</a:t>
            </a:r>
            <a:br>
              <a:rPr kumimoji="1" lang="en-US" altLang="zh-CN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200" dirty="0"/>
              <a:t>Figure S1: Phylogenetic tree of coat protein (CP) coding sequences</a:t>
            </a:r>
            <a:r>
              <a:rPr kumimoji="1" lang="en-US" altLang="zh-CN" sz="1200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kumimoji="1" lang="zh-CN" altLang="en-US" sz="1200" b="1" dirty="0">
              <a:solidFill>
                <a:srgbClr val="0432FF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723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EE15319B-32D9-4F85-B54D-257108318AE6}"/>
              </a:ext>
            </a:extLst>
          </p:cNvPr>
          <p:cNvGrpSpPr/>
          <p:nvPr/>
        </p:nvGrpSpPr>
        <p:grpSpPr>
          <a:xfrm>
            <a:off x="95151" y="1504748"/>
            <a:ext cx="6678798" cy="6301307"/>
            <a:chOff x="82450" y="1504746"/>
            <a:chExt cx="6678797" cy="6301306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02FE728D-2EA6-44AB-A3DF-19E657A1A6C3}"/>
                </a:ext>
              </a:extLst>
            </p:cNvPr>
            <p:cNvGrpSpPr/>
            <p:nvPr/>
          </p:nvGrpSpPr>
          <p:grpSpPr>
            <a:xfrm>
              <a:off x="96753" y="1504747"/>
              <a:ext cx="6656473" cy="6301305"/>
              <a:chOff x="68178" y="1504747"/>
              <a:chExt cx="6656473" cy="6301305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02FB1519-3CB5-48CD-B3BE-D6AB564EEF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28" t="1" r="25763" b="36096"/>
              <a:stretch/>
            </p:blipFill>
            <p:spPr>
              <a:xfrm>
                <a:off x="885826" y="1504747"/>
                <a:ext cx="5838824" cy="5279490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DDDD2C63-8D52-4449-AD42-1BC12891D9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t="1" r="90313" b="36096"/>
              <a:stretch/>
            </p:blipFill>
            <p:spPr>
              <a:xfrm>
                <a:off x="68178" y="1504747"/>
                <a:ext cx="903372" cy="527949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D201CF85-9F25-4BC4-AEC4-AE2BBE03C0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62" t="64951" r="25730" b="21960"/>
              <a:stretch/>
            </p:blipFill>
            <p:spPr>
              <a:xfrm>
                <a:off x="885827" y="6724650"/>
                <a:ext cx="5838824" cy="1081402"/>
              </a:xfrm>
              <a:prstGeom prst="rect">
                <a:avLst/>
              </a:prstGeom>
            </p:spPr>
          </p:pic>
        </p:grp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CC194C5B-9AB5-495A-9B26-3CFAFD70D5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726" t="30274" r="21140" b="52352"/>
            <a:stretch/>
          </p:blipFill>
          <p:spPr>
            <a:xfrm>
              <a:off x="6096000" y="1504746"/>
              <a:ext cx="665247" cy="1435401"/>
            </a:xfrm>
            <a:prstGeom prst="rect">
              <a:avLst/>
            </a:prstGeom>
          </p:spPr>
        </p:pic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48CE04D8-BBCD-4EB3-BE51-7A054A634905}"/>
                </a:ext>
              </a:extLst>
            </p:cNvPr>
            <p:cNvSpPr/>
            <p:nvPr/>
          </p:nvSpPr>
          <p:spPr>
            <a:xfrm>
              <a:off x="82450" y="6016217"/>
              <a:ext cx="812900" cy="14328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2"/>
              <a:endParaRPr lang="zh-CN" altLang="en-US">
                <a:solidFill>
                  <a:prstClr val="white"/>
                </a:solidFill>
                <a:latin typeface="等线" panose="020F0502020204030204"/>
                <a:ea typeface="等线" panose="02010600030101010101" pitchFamily="2" charset="-122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C9DA85E6-8E35-4603-87F6-43B24CE562BF}"/>
                </a:ext>
              </a:extLst>
            </p:cNvPr>
            <p:cNvSpPr/>
            <p:nvPr/>
          </p:nvSpPr>
          <p:spPr>
            <a:xfrm rot="5400000">
              <a:off x="5616074" y="7244008"/>
              <a:ext cx="884984" cy="15106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2"/>
              <a:endParaRPr lang="zh-CN" altLang="en-US">
                <a:solidFill>
                  <a:prstClr val="white"/>
                </a:solidFill>
                <a:latin typeface="等线" panose="020F0502020204030204"/>
                <a:ea typeface="等线" panose="02010600030101010101" pitchFamily="2" charset="-122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7AD4EBE0-69C6-40D2-9964-2F53A2CFDF7A}"/>
              </a:ext>
            </a:extLst>
          </p:cNvPr>
          <p:cNvSpPr txBox="1"/>
          <p:nvPr/>
        </p:nvSpPr>
        <p:spPr>
          <a:xfrm>
            <a:off x="-1" y="0"/>
            <a:ext cx="544907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upplementary Figure S2 </a:t>
            </a:r>
            <a:br>
              <a:rPr kumimoji="1" lang="en-US" altLang="zh-CN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200" dirty="0"/>
              <a:t>Figure S2: Consistency analysis of CP coding sequences</a:t>
            </a:r>
            <a:endParaRPr kumimoji="1" lang="zh-CN" altLang="en-US" sz="1200" b="1" dirty="0">
              <a:solidFill>
                <a:srgbClr val="0432FF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8198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组合 71">
            <a:extLst>
              <a:ext uri="{FF2B5EF4-FFF2-40B4-BE49-F238E27FC236}">
                <a16:creationId xmlns:a16="http://schemas.microsoft.com/office/drawing/2014/main" id="{9145B83B-4869-4C18-AEB8-59C2A0295A9A}"/>
              </a:ext>
            </a:extLst>
          </p:cNvPr>
          <p:cNvGrpSpPr/>
          <p:nvPr/>
        </p:nvGrpSpPr>
        <p:grpSpPr>
          <a:xfrm>
            <a:off x="105555" y="1181393"/>
            <a:ext cx="6827121" cy="5113859"/>
            <a:chOff x="75075" y="1049313"/>
            <a:chExt cx="6827121" cy="5113859"/>
          </a:xfrm>
        </p:grpSpPr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3E55A57B-FDC5-4592-A37F-3F1ECA9A965A}"/>
                </a:ext>
              </a:extLst>
            </p:cNvPr>
            <p:cNvGrpSpPr/>
            <p:nvPr/>
          </p:nvGrpSpPr>
          <p:grpSpPr>
            <a:xfrm>
              <a:off x="156355" y="1435158"/>
              <a:ext cx="6545290" cy="2039062"/>
              <a:chOff x="214267" y="343344"/>
              <a:chExt cx="6545290" cy="2039062"/>
            </a:xfrm>
          </p:grpSpPr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E869E319-F120-4781-8854-7FE492CBD438}"/>
                  </a:ext>
                </a:extLst>
              </p:cNvPr>
              <p:cNvGrpSpPr/>
              <p:nvPr/>
            </p:nvGrpSpPr>
            <p:grpSpPr>
              <a:xfrm>
                <a:off x="5497630" y="343344"/>
                <a:ext cx="1261927" cy="2039062"/>
                <a:chOff x="5376617" y="2257488"/>
                <a:chExt cx="1261927" cy="2039062"/>
              </a:xfrm>
            </p:grpSpPr>
            <p:pic>
              <p:nvPicPr>
                <p:cNvPr id="18" name="图片 17">
                  <a:extLst>
                    <a:ext uri="{FF2B5EF4-FFF2-40B4-BE49-F238E27FC236}">
                      <a16:creationId xmlns:a16="http://schemas.microsoft.com/office/drawing/2014/main" id="{40F85EDF-A08A-46EF-9E75-FAA8C9E41E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4908"/>
                <a:stretch/>
              </p:blipFill>
              <p:spPr>
                <a:xfrm>
                  <a:off x="5692085" y="2257488"/>
                  <a:ext cx="946459" cy="2039062"/>
                </a:xfrm>
                <a:prstGeom prst="rect">
                  <a:avLst/>
                </a:prstGeom>
              </p:spPr>
            </p:pic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0739571A-4A92-4389-A52F-CF645CFD5424}"/>
                    </a:ext>
                  </a:extLst>
                </p:cNvPr>
                <p:cNvSpPr txBox="1"/>
                <p:nvPr/>
              </p:nvSpPr>
              <p:spPr>
                <a:xfrm>
                  <a:off x="5376617" y="3076964"/>
                  <a:ext cx="59436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…</a:t>
                  </a:r>
                  <a:endParaRPr lang="zh-CN" altLang="en-US" sz="20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EA5052D9-36C4-4818-B6FC-C0C1E73D6F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3398"/>
              <a:stretch/>
            </p:blipFill>
            <p:spPr>
              <a:xfrm>
                <a:off x="214267" y="350948"/>
                <a:ext cx="5345284" cy="2031458"/>
              </a:xfrm>
              <a:prstGeom prst="rect">
                <a:avLst/>
              </a:prstGeom>
            </p:spPr>
          </p:pic>
        </p:grpSp>
        <p:grpSp>
          <p:nvGrpSpPr>
            <p:cNvPr id="69" name="组合 68">
              <a:extLst>
                <a:ext uri="{FF2B5EF4-FFF2-40B4-BE49-F238E27FC236}">
                  <a16:creationId xmlns:a16="http://schemas.microsoft.com/office/drawing/2014/main" id="{FBEE579A-B358-405E-A233-6539349BEF6F}"/>
                </a:ext>
              </a:extLst>
            </p:cNvPr>
            <p:cNvGrpSpPr/>
            <p:nvPr/>
          </p:nvGrpSpPr>
          <p:grpSpPr>
            <a:xfrm>
              <a:off x="156355" y="5371109"/>
              <a:ext cx="6745841" cy="792063"/>
              <a:chOff x="156355" y="4995189"/>
              <a:chExt cx="6745841" cy="792063"/>
            </a:xfrm>
          </p:grpSpPr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A68652CB-FDD3-4869-906E-949670E860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56355" y="4995189"/>
                <a:ext cx="6545290" cy="428068"/>
              </a:xfrm>
              <a:prstGeom prst="rect">
                <a:avLst/>
              </a:prstGeom>
            </p:spPr>
          </p:pic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D82DA739-A168-4514-8AFB-EE45535B47C6}"/>
                  </a:ext>
                </a:extLst>
              </p:cNvPr>
              <p:cNvGrpSpPr/>
              <p:nvPr/>
            </p:nvGrpSpPr>
            <p:grpSpPr>
              <a:xfrm>
                <a:off x="5348985" y="5457236"/>
                <a:ext cx="1553211" cy="233836"/>
                <a:chOff x="5353048" y="1726713"/>
                <a:chExt cx="1553211" cy="233836"/>
              </a:xfrm>
            </p:grpSpPr>
            <p:sp>
              <p:nvSpPr>
                <p:cNvPr id="63" name="箭头: 右 62">
                  <a:extLst>
                    <a:ext uri="{FF2B5EF4-FFF2-40B4-BE49-F238E27FC236}">
                      <a16:creationId xmlns:a16="http://schemas.microsoft.com/office/drawing/2014/main" id="{F1D16CEC-F142-4587-9A0F-E3B85C4AE9E4}"/>
                    </a:ext>
                  </a:extLst>
                </p:cNvPr>
                <p:cNvSpPr/>
                <p:nvPr/>
              </p:nvSpPr>
              <p:spPr>
                <a:xfrm flipH="1">
                  <a:off x="5353048" y="1726713"/>
                  <a:ext cx="1350012" cy="233836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119459D7-94D2-4853-BE1F-EA4A3E39A9F2}"/>
                    </a:ext>
                  </a:extLst>
                </p:cNvPr>
                <p:cNvSpPr txBox="1"/>
                <p:nvPr/>
              </p:nvSpPr>
              <p:spPr>
                <a:xfrm flipH="1">
                  <a:off x="5353048" y="1751298"/>
                  <a:ext cx="155321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GATTGGGGCCCATCCCCGGG</a:t>
                  </a:r>
                  <a:r>
                    <a:rPr lang="en-US" altLang="zh-CN" sz="600" dirty="0">
                      <a:solidFill>
                        <a:srgbClr val="FFFF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</a:t>
                  </a:r>
                  <a:r>
                    <a:rPr lang="en-US" altLang="zh-CN" sz="6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</a:t>
                  </a:r>
                  <a:endParaRPr lang="zh-CN" altLang="en-US" sz="6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D74D779D-BAAD-4C98-989D-78D9C8B3BED0}"/>
                  </a:ext>
                </a:extLst>
              </p:cNvPr>
              <p:cNvSpPr txBox="1"/>
              <p:nvPr/>
            </p:nvSpPr>
            <p:spPr>
              <a:xfrm>
                <a:off x="5836980" y="5594892"/>
                <a:ext cx="777877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oMV</a:t>
                </a:r>
                <a:r>
                  <a:rPr lang="en-US" altLang="zh-CN" sz="6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YZ-R</a:t>
                </a:r>
                <a:endParaRPr lang="zh-CN" altLang="en-US" sz="6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0C853618-252B-4D13-8945-FD9859370FF0}"/>
                </a:ext>
              </a:extLst>
            </p:cNvPr>
            <p:cNvSpPr txBox="1"/>
            <p:nvPr/>
          </p:nvSpPr>
          <p:spPr>
            <a:xfrm>
              <a:off x="75075" y="1049313"/>
              <a:ext cx="3831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8294B779-C1BC-409A-9B0D-7D209A4F7E5B}"/>
                </a:ext>
              </a:extLst>
            </p:cNvPr>
            <p:cNvGrpSpPr/>
            <p:nvPr/>
          </p:nvGrpSpPr>
          <p:grpSpPr>
            <a:xfrm>
              <a:off x="75075" y="3816703"/>
              <a:ext cx="6626570" cy="1141767"/>
              <a:chOff x="75075" y="3816703"/>
              <a:chExt cx="6626570" cy="1141767"/>
            </a:xfrm>
          </p:grpSpPr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FABDF496-1A1E-45B3-BCF5-338C62C03E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56355" y="4175713"/>
                <a:ext cx="6545290" cy="434743"/>
              </a:xfrm>
              <a:prstGeom prst="rect">
                <a:avLst/>
              </a:prstGeom>
            </p:spPr>
          </p:pic>
          <p:grpSp>
            <p:nvGrpSpPr>
              <p:cNvPr id="58" name="组合 57">
                <a:extLst>
                  <a:ext uri="{FF2B5EF4-FFF2-40B4-BE49-F238E27FC236}">
                    <a16:creationId xmlns:a16="http://schemas.microsoft.com/office/drawing/2014/main" id="{7FB0AFE0-81A3-4422-89DB-5EE70570827C}"/>
                  </a:ext>
                </a:extLst>
              </p:cNvPr>
              <p:cNvGrpSpPr/>
              <p:nvPr/>
            </p:nvGrpSpPr>
            <p:grpSpPr>
              <a:xfrm>
                <a:off x="2166369" y="4610456"/>
                <a:ext cx="2162808" cy="233836"/>
                <a:chOff x="1616712" y="1757524"/>
                <a:chExt cx="2162808" cy="233836"/>
              </a:xfrm>
            </p:grpSpPr>
            <p:sp>
              <p:nvSpPr>
                <p:cNvPr id="59" name="箭头: 右 58">
                  <a:extLst>
                    <a:ext uri="{FF2B5EF4-FFF2-40B4-BE49-F238E27FC236}">
                      <a16:creationId xmlns:a16="http://schemas.microsoft.com/office/drawing/2014/main" id="{FD945E2C-AB19-4499-AD4C-265D2A5FF134}"/>
                    </a:ext>
                  </a:extLst>
                </p:cNvPr>
                <p:cNvSpPr/>
                <p:nvPr/>
              </p:nvSpPr>
              <p:spPr>
                <a:xfrm>
                  <a:off x="1700532" y="1757524"/>
                  <a:ext cx="1977388" cy="233836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6CC28367-5DAF-48AA-A26C-E9A5BB9A4BEB}"/>
                    </a:ext>
                  </a:extLst>
                </p:cNvPr>
                <p:cNvSpPr txBox="1"/>
                <p:nvPr/>
              </p:nvSpPr>
              <p:spPr>
                <a:xfrm>
                  <a:off x="1616712" y="1775522"/>
                  <a:ext cx="2162808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GTTTTA</a:t>
                  </a:r>
                  <a:r>
                    <a:rPr lang="en-US" altLang="zh-CN" sz="650" dirty="0">
                      <a:solidFill>
                        <a:srgbClr val="FFFF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W</a:t>
                  </a:r>
                  <a:r>
                    <a:rPr lang="en-US" altLang="zh-CN" sz="65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TTTT</a:t>
                  </a:r>
                  <a:r>
                    <a:rPr lang="en-US" altLang="zh-CN" sz="650" dirty="0">
                      <a:solidFill>
                        <a:srgbClr val="FFFF00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R</a:t>
                  </a:r>
                  <a:r>
                    <a:rPr lang="en-US" altLang="zh-CN" sz="65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TTGCAACAACAACAACAAATTA</a:t>
                  </a:r>
                  <a:endParaRPr lang="zh-CN" altLang="en-US" sz="65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3BF399E2-3F0F-483D-8825-592DCE96F0AC}"/>
                  </a:ext>
                </a:extLst>
              </p:cNvPr>
              <p:cNvSpPr txBox="1"/>
              <p:nvPr/>
            </p:nvSpPr>
            <p:spPr>
              <a:xfrm>
                <a:off x="2808353" y="4766110"/>
                <a:ext cx="667384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oMV</a:t>
                </a:r>
                <a:r>
                  <a:rPr lang="en-US" altLang="zh-CN" sz="6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YZ-F</a:t>
                </a:r>
                <a:endParaRPr lang="zh-CN" altLang="en-US" sz="6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EAB3E43A-88A4-4E12-823F-651F2A542EC7}"/>
                  </a:ext>
                </a:extLst>
              </p:cNvPr>
              <p:cNvSpPr txBox="1"/>
              <p:nvPr/>
            </p:nvSpPr>
            <p:spPr>
              <a:xfrm>
                <a:off x="75075" y="3816703"/>
                <a:ext cx="38310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404643F3-A256-4394-A5D4-7F155C87285E}"/>
                </a:ext>
              </a:extLst>
            </p:cNvPr>
            <p:cNvSpPr txBox="1"/>
            <p:nvPr/>
          </p:nvSpPr>
          <p:spPr>
            <a:xfrm>
              <a:off x="75075" y="5002632"/>
              <a:ext cx="3831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3" name="文本框 72">
            <a:extLst>
              <a:ext uri="{FF2B5EF4-FFF2-40B4-BE49-F238E27FC236}">
                <a16:creationId xmlns:a16="http://schemas.microsoft.com/office/drawing/2014/main" id="{B35F0CBA-B87D-4177-9157-211C4C972CFB}"/>
              </a:ext>
            </a:extLst>
          </p:cNvPr>
          <p:cNvSpPr txBox="1"/>
          <p:nvPr/>
        </p:nvSpPr>
        <p:spPr>
          <a:xfrm>
            <a:off x="-1" y="0"/>
            <a:ext cx="672947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upplementary Figure S3 </a:t>
            </a:r>
            <a:br>
              <a:rPr kumimoji="1" lang="en-US" altLang="zh-CN" b="1" dirty="0">
                <a:solidFill>
                  <a:srgbClr val="0432FF"/>
                </a:solidFill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200" dirty="0"/>
              <a:t>Figure S3: </a:t>
            </a:r>
            <a:r>
              <a:rPr lang="en-US" sz="1200" dirty="0" err="1"/>
              <a:t>YoMV</a:t>
            </a:r>
            <a:r>
              <a:rPr lang="en-US" sz="1200" dirty="0"/>
              <a:t> isolates sequence alignment and terminal primers. (A). 3‘- and 5’-terminus sequence alignment of all </a:t>
            </a:r>
            <a:r>
              <a:rPr lang="en-US" sz="1200" dirty="0" err="1"/>
              <a:t>YoMV</a:t>
            </a:r>
            <a:r>
              <a:rPr lang="en-US" sz="1200" dirty="0"/>
              <a:t> isolates. (B). Alignment of 5′ sequence from </a:t>
            </a:r>
            <a:r>
              <a:rPr lang="en-US" sz="1200" dirty="0" err="1"/>
              <a:t>YoMV</a:t>
            </a:r>
            <a:r>
              <a:rPr lang="en-US" sz="1200" dirty="0"/>
              <a:t> Chinese mainland isolates and </a:t>
            </a:r>
            <a:r>
              <a:rPr lang="en-US" sz="1200" dirty="0" err="1"/>
              <a:t>YoMV</a:t>
            </a:r>
            <a:r>
              <a:rPr lang="en-US" sz="1200" dirty="0"/>
              <a:t>-YZ-F primer design. (C). Alignment of 3′ sequence from </a:t>
            </a:r>
            <a:r>
              <a:rPr lang="en-US" sz="1200" dirty="0" err="1"/>
              <a:t>YoMV</a:t>
            </a:r>
            <a:r>
              <a:rPr lang="en-US" sz="1200" dirty="0"/>
              <a:t> Chinese mainland isolates and </a:t>
            </a:r>
            <a:r>
              <a:rPr lang="en-US" sz="1200" dirty="0" err="1"/>
              <a:t>YoMV</a:t>
            </a:r>
            <a:r>
              <a:rPr lang="en-US" sz="1200" dirty="0"/>
              <a:t>-YZ-R primer design</a:t>
            </a:r>
            <a:endParaRPr kumimoji="1" lang="zh-CN" altLang="en-US" sz="1200" b="1" dirty="0">
              <a:solidFill>
                <a:srgbClr val="0432FF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8545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7</TotalTime>
  <Words>129</Words>
  <Application>Microsoft Office PowerPoint</Application>
  <PresentationFormat>A4 Paper (210x297 mm)</PresentationFormat>
  <Paragraphs>1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1_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 TX</dc:creator>
  <cp:lastModifiedBy>MDPI</cp:lastModifiedBy>
  <cp:revision>29</cp:revision>
  <dcterms:created xsi:type="dcterms:W3CDTF">2023-08-29T07:41:11Z</dcterms:created>
  <dcterms:modified xsi:type="dcterms:W3CDTF">2024-01-28T05:52:04Z</dcterms:modified>
</cp:coreProperties>
</file>